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ECEF1-F823-44DE-BECF-5EA4903CFE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541A6B-F4FD-432A-921F-592DD90CC4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86395-71F8-4FBB-AF63-F54820C933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07FBF-7425-4418-A500-9F86C9597E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6C1B2-8388-4D91-878D-CCD60CDDC1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CDAE0-C344-41F3-B9FB-21C5F9380A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0D9BE-CBF9-4674-86E6-97E7A202E1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3F59B-4262-40D7-BAD9-EC21FDDB73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2727B-81D1-4F49-AD0C-E7F1CBACD7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51EDA-68A8-4061-8B4C-1C079050CB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871EB-3D06-4FDF-8C9D-7B5ABD7DB6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EAC91-7347-46E2-AFE3-705A845162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660C0C-BDD5-49DD-9DF9-3F8FAF22AF4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0"/>
            <a:ext cx="0" cy="0"/>
            <a:chOff x="0" y="0"/>
            <a:chExt cx="0" cy="0"/>
          </a:xfrm>
        </p:grpSpPr>
      </p:grpSp>
      <p:grpSp>
        <p:nvGrpSpPr>
          <p:cNvPr id="42" name=""/>
          <p:cNvGrpSpPr/>
          <p:nvPr/>
        </p:nvGrpSpPr>
        <p:grpSpPr>
          <a:xfrm>
            <a:off x="0" y="0"/>
            <a:ext cx="0" cy="0"/>
            <a:chOff x="0" y="0"/>
            <a:chExt cx="0" cy="0"/>
          </a:xfrm>
        </p:grpSpPr>
      </p:grpSp>
      <p:sp>
        <p:nvSpPr>
          <p:cNvPr id="43" name=""/>
          <p:cNvSpPr/>
          <p:nvPr/>
        </p:nvSpPr>
        <p:spPr>
          <a:xfrm>
            <a:off x="4203720" y="3429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118120" y="3429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603840" y="3429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603520" y="3429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803240" y="2590920"/>
            <a:ext cx="160020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5 n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866960" y="3048120"/>
            <a:ext cx="5600520" cy="457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Mammalian             Native light chain                 Mammalian            Native heavy chain variable/ IgG CH1,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elements           variable/constant region           elements                          hinge, CH2, and CH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17720" y="3619440"/>
            <a:ext cx="548640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Hind III    Sfi I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Not I Nhe I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sc I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ge I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(Pin A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317840" y="3429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981080" y="2057400"/>
            <a:ext cx="5435640" cy="38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Hind III  Sfi I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Xba I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     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ac I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Not I Nh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Hind III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Xho I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              Age I (Pin AI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232240" y="304812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203720" y="304812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717640" y="304812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866960" y="1481040"/>
            <a:ext cx="5600520" cy="457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Mammalian                 Light chain                     Mammalian               Heavy chain variable/ IgG CH1,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elements          variable/constant region           elements                          hinge, CH2, and CH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214880" y="1477800"/>
            <a:ext cx="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728800" y="1477800"/>
            <a:ext cx="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232240" y="1446120"/>
            <a:ext cx="0" cy="57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986280" y="1820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614680" y="1820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329000" y="1820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603840" y="1820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374920" y="1820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118120" y="18208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374920" y="3429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800600" y="2286000"/>
            <a:ext cx="129528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(1)     (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124080" y="2289240"/>
            <a:ext cx="22860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3352680" y="2288880"/>
            <a:ext cx="34308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800600" y="2286000"/>
            <a:ext cx="228600" cy="1371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906200" y="1119240"/>
            <a:ext cx="951840" cy="44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5 eIgG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754280" y="1544400"/>
            <a:ext cx="18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800"/>
            </a:b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200400" y="1121760"/>
            <a:ext cx="38088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                         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2)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754280" y="3809880"/>
            <a:ext cx="18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800"/>
            </a:b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752480" y="59878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752480" y="671976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1T19:24:26Z</dcterms:created>
  <dc:creator>Computing Resources Group</dc:creator>
  <dc:description/>
  <dc:language>en-US</dc:language>
  <cp:lastModifiedBy>Computing Resources Group</cp:lastModifiedBy>
  <dcterms:modified xsi:type="dcterms:W3CDTF">2010-01-19T20:27:37Z</dcterms:modified>
  <cp:revision>7</cp:revision>
  <dc:subject/>
  <dc:title>Slide 1</dc:title>
</cp:coreProperties>
</file>